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-520" y="-12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8084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3881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8248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086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6444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404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972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4548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8537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420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4424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F72C35-35AF-4D10-BBB3-35E6CF7FF518}" type="datetimeFigureOut">
              <a:rPr lang="en-GB" smtClean="0"/>
              <a:t>22/02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44571-3C12-4E5C-8403-26AB494B89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525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54979" y="1101970"/>
            <a:ext cx="5825951" cy="7729375"/>
            <a:chOff x="245094" y="1074156"/>
            <a:chExt cx="6023347" cy="8249557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630" y="1091095"/>
              <a:ext cx="3113671" cy="1937395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79335" y="1074156"/>
              <a:ext cx="3060604" cy="1958787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79335" y="3098347"/>
              <a:ext cx="3089106" cy="2031945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012" y="5235363"/>
              <a:ext cx="3102786" cy="1985783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84129" y="5180317"/>
              <a:ext cx="3084312" cy="2056208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094" y="2998394"/>
              <a:ext cx="3440243" cy="2201756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630" y="7181479"/>
              <a:ext cx="3109694" cy="2142234"/>
            </a:xfrm>
            <a:prstGeom prst="rect">
              <a:avLst/>
            </a:prstGeom>
          </p:spPr>
        </p:pic>
      </p:grpSp>
      <p:sp>
        <p:nvSpPr>
          <p:cNvPr id="5" name="TextBox 4"/>
          <p:cNvSpPr txBox="1"/>
          <p:nvPr/>
        </p:nvSpPr>
        <p:spPr>
          <a:xfrm>
            <a:off x="721745" y="224133"/>
            <a:ext cx="56968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Times New Roman"/>
                <a:cs typeface="Times New Roman"/>
              </a:rPr>
              <a:t>Figure S2 - </a:t>
            </a:r>
            <a:r>
              <a:rPr lang="en-US" sz="1200" dirty="0">
                <a:latin typeface="Times New Roman"/>
                <a:cs typeface="Times New Roman"/>
              </a:rPr>
              <a:t>Calibration curves obtained for each analyte in artificial plasma extracts showing the linear correlation between signal (area ratio shown in y axis) and concentration (ng/ml shown in x axis). The curve equation and r squared are also shown. The compounds are abbreviated as shown in Table 1.</a:t>
            </a:r>
            <a:endParaRPr lang="pt-BR" sz="1200" dirty="0">
              <a:latin typeface="Times New Roman"/>
              <a:cs typeface="Times New Roman"/>
            </a:endParaRPr>
          </a:p>
          <a:p>
            <a:r>
              <a:rPr lang="en-US" sz="1200" b="1" dirty="0" smtClean="0">
                <a:latin typeface="Times New Roman"/>
                <a:cs typeface="Times New Roman"/>
              </a:rPr>
              <a:t> </a:t>
            </a:r>
            <a:endParaRPr lang="en-US" sz="12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6730032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60</Words>
  <Application>Microsoft Macintosh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zabella Neshich</dc:creator>
  <cp:lastModifiedBy>Paulo Arruda</cp:lastModifiedBy>
  <cp:revision>9</cp:revision>
  <dcterms:created xsi:type="dcterms:W3CDTF">2015-05-22T10:49:26Z</dcterms:created>
  <dcterms:modified xsi:type="dcterms:W3CDTF">2016-02-22T05:49:20Z</dcterms:modified>
</cp:coreProperties>
</file>